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7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17F8249-BCAA-4D59-A84B-C12B49DE95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71E63516-E4F3-474D-ACF1-F50F2D9130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8952EBF-245A-40E8-A340-93C85419E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7E4E256-E39B-466C-A885-12A0CBD3D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58001CF-93C1-42D8-80E7-0BC69FDE8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909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ED02D1F-CDBC-4232-911B-A443479F9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B4B620B-E41D-477A-94D9-0DAA55862F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2800C37-35FF-4E89-9577-03D15F668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6189635-DE49-4A33-9AA6-1BD3EA080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0C54AAB-F43D-454C-B57A-92CF32603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944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0808FF57-A2CC-4273-A32A-7EAE58EC21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9A440901-E649-412C-9D45-D85B72B905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466C7B2-F0EC-4B82-ACE6-38236F9D3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7DB76BA-FBC0-48E8-9DC7-6556BBD17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BFE72D9-2ACA-453C-B4B2-6330A434D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928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9698A4E-784F-4493-85BC-4135FA696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22874EF-29B5-40E4-AA6F-17B03377DF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87F8958-5793-4FA3-B819-48B7A7D9C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245F502-C829-4B5F-947C-539397AA8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15CAC17-17B5-46FE-9D62-04BA65987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956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8F0AD9A-A595-40E0-ABBA-93EB3CA22E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E0E925C-2A5C-4B06-AF16-9440D0C84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0BB22B2-F4B5-4C36-8B5D-F349669AA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638C331-44FE-4B72-A45B-01ABB8028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963309C-4BDF-468E-9738-0202E06EC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66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AF90B48-4B16-4AD1-B475-4A6FDAD016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17948F8-12C5-44E6-8DFA-154C312583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9171C283-DA2A-47EE-8F8E-5A6A41469E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9AC48DD-E541-4D12-8422-8CAB9AB5D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84002AC-59E5-4F6F-B982-3C392BCBB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4CFD571-59E6-4F95-8E5D-A32790A3A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60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E3AAB00-2A9D-4BF2-A623-08637AE90B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3B48385-B89E-4C63-B810-1C99DB1DAB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9654B968-EA25-428A-A61B-7CA1964966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E5FE92EE-399E-4EE4-8B84-7F882EE148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F949C5E3-D1B1-4EFA-9861-6AB3A7ECE4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FCD16303-BD5F-428A-B846-B2FAFA137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B9492441-0C86-4B87-9CA5-AACB36080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221B038B-5308-45E9-B85E-C2EB00420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35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D4B709D-2E27-4E81-AF90-95ADEB3C4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5008E161-637A-4CFF-9307-0AB2970F0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5CFC8FA2-4AF0-4FBF-8133-2615AADE7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0A3D4126-8894-4AA7-A9FD-643920617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260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0B286C67-1FEC-448A-A398-75083B68B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9CA50AC5-8ED0-4077-A92F-B426EADB4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C01707A2-11E8-46ED-BF0E-40DB115FE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103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A69FAF1-57D1-4D43-8872-89DCFB35C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79FCBD5-C317-4CB0-B84F-B77C808549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BB5B89FD-DE02-4470-A7ED-0A4BF239C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2D75096-8959-4D2A-AD03-56A355AF8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99ADB1F5-8EDC-4BD8-A9BE-04B076C34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4B38A7D6-E2D9-46C6-97C0-2C136569A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216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B790C64-6280-4371-BB4C-F02F9B564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183E5E3B-25DE-4FBF-8CCF-8BC1AA1743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DA1C3D7E-4129-430E-B582-BE9BCECE5F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0FC54CB-9894-45F0-998C-2BB22C820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66970D8F-A09C-4E1C-80F3-85BF4D60B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2D33349-B157-4291-B135-8F448B18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502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E47FD21B-D375-4A5B-9E70-9338B563E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939B81E-F546-4376-A09F-E2216D6960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5DD7DF4-7E86-4FD8-817B-7599DE3532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5F7FC-279B-4709-9104-5CF2A5951049}" type="datetimeFigureOut">
              <a:rPr kumimoji="1" lang="ja-JP" altLang="en-US" smtClean="0"/>
              <a:t>2019/12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9EBCDC8-2A4F-4C3B-A5FA-80D0691BE6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65E762C-6C1D-42FC-8517-D1BB50093C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6EEB8-B75D-4D6C-A121-B7AC9F9C35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069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5719BE1B-6D05-43BC-94EF-83257BF60273}"/>
              </a:ext>
            </a:extLst>
          </p:cNvPr>
          <p:cNvSpPr/>
          <p:nvPr/>
        </p:nvSpPr>
        <p:spPr>
          <a:xfrm>
            <a:off x="201196" y="298285"/>
            <a:ext cx="4488250" cy="5070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8D2F0D2A-65EF-461B-A570-125F9D57D269}"/>
              </a:ext>
            </a:extLst>
          </p:cNvPr>
          <p:cNvSpPr/>
          <p:nvPr/>
        </p:nvSpPr>
        <p:spPr>
          <a:xfrm>
            <a:off x="304027" y="5979812"/>
            <a:ext cx="110172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1: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hase-contrast</a:t>
            </a:r>
            <a:r>
              <a:rPr lang="ja-JP" alt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icrographs</a:t>
            </a:r>
            <a:r>
              <a:rPr lang="ja-JP" alt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</a:t>
            </a:r>
            <a:r>
              <a:rPr lang="ja-JP" alt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AV-infected (A) and mock-infected (B) C6/36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s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t 3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ays </a:t>
            </a:r>
            <a:r>
              <a:rPr lang="en-US" altLang="ja-JP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ostinfection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ja-JP" altLang="en-US" dirty="0"/>
          </a:p>
        </p:txBody>
      </p:sp>
      <p:pic>
        <p:nvPicPr>
          <p:cNvPr id="11" name="Picture 2">
            <a:extLst>
              <a:ext uri="{FF2B5EF4-FFF2-40B4-BE49-F238E27FC236}">
                <a16:creationId xmlns:a16="http://schemas.microsoft.com/office/drawing/2014/main" xmlns="" id="{DA955DF5-6515-4DB4-9481-25F6062C3C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screen"/>
          <a:srcRect/>
          <a:stretch>
            <a:fillRect/>
          </a:stretch>
        </p:blipFill>
        <p:spPr bwMode="auto">
          <a:xfrm>
            <a:off x="80052" y="1159474"/>
            <a:ext cx="5918076" cy="40814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2" name="Picture 3">
            <a:extLst>
              <a:ext uri="{FF2B5EF4-FFF2-40B4-BE49-F238E27FC236}">
                <a16:creationId xmlns:a16="http://schemas.microsoft.com/office/drawing/2014/main" xmlns="" id="{855F808E-DF38-4535-BB91-E857571C07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screen"/>
          <a:srcRect/>
          <a:stretch>
            <a:fillRect/>
          </a:stretch>
        </p:blipFill>
        <p:spPr bwMode="auto">
          <a:xfrm>
            <a:off x="6110248" y="1162745"/>
            <a:ext cx="5913332" cy="40781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F0DCB70A-DA16-4AD8-98C0-53F8AA2D6AB7}"/>
              </a:ext>
            </a:extLst>
          </p:cNvPr>
          <p:cNvSpPr/>
          <p:nvPr/>
        </p:nvSpPr>
        <p:spPr>
          <a:xfrm>
            <a:off x="201196" y="1271225"/>
            <a:ext cx="360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FA81DD9C-36BD-4B01-8B6A-3340952191E1}"/>
              </a:ext>
            </a:extLst>
          </p:cNvPr>
          <p:cNvSpPr/>
          <p:nvPr/>
        </p:nvSpPr>
        <p:spPr>
          <a:xfrm>
            <a:off x="6236442" y="1271225"/>
            <a:ext cx="360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7752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DC0CAD97-F09D-4320-BE2A-558D452DE9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057" y="1057013"/>
            <a:ext cx="5922627" cy="44249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xmlns="" id="{04A0AFCA-A211-4A9E-8640-B0D02E8AFD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2520" y="1057013"/>
            <a:ext cx="5922626" cy="44249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F0DCB70A-DA16-4AD8-98C0-53F8AA2D6AB7}"/>
              </a:ext>
            </a:extLst>
          </p:cNvPr>
          <p:cNvSpPr/>
          <p:nvPr/>
        </p:nvSpPr>
        <p:spPr>
          <a:xfrm>
            <a:off x="201196" y="1178652"/>
            <a:ext cx="360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FA81DD9C-36BD-4B01-8B6A-3340952191E1}"/>
              </a:ext>
            </a:extLst>
          </p:cNvPr>
          <p:cNvSpPr/>
          <p:nvPr/>
        </p:nvSpPr>
        <p:spPr>
          <a:xfrm>
            <a:off x="6295165" y="1178652"/>
            <a:ext cx="360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5719BE1B-6D05-43BC-94EF-83257BF60273}"/>
              </a:ext>
            </a:extLst>
          </p:cNvPr>
          <p:cNvSpPr/>
          <p:nvPr/>
        </p:nvSpPr>
        <p:spPr>
          <a:xfrm>
            <a:off x="201196" y="298285"/>
            <a:ext cx="4488250" cy="5070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8D2F0D2A-65EF-461B-A570-125F9D57D269}"/>
              </a:ext>
            </a:extLst>
          </p:cNvPr>
          <p:cNvSpPr/>
          <p:nvPr/>
        </p:nvSpPr>
        <p:spPr>
          <a:xfrm>
            <a:off x="304027" y="5979812"/>
            <a:ext cx="113460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2: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hase-contrast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icrographs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 </a:t>
            </a:r>
            <a:r>
              <a:rPr lang="en-US" altLang="ja-JP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CV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infected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A) and mock-infected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B) C6/36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s at 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6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ays </a:t>
            </a:r>
            <a:r>
              <a:rPr lang="en-US" altLang="ja-JP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ostinfection</a:t>
            </a:r>
            <a:r>
              <a:rPr lang="en-US" altLang="ja-JP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altLang="ja-JP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4433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56</Words>
  <Application>Microsoft Office PowerPoint</Application>
  <PresentationFormat>ワイド画面</PresentationFormat>
  <Paragraphs>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bayashi</dc:creator>
  <cp:lastModifiedBy>Haruhiko ISAWA</cp:lastModifiedBy>
  <cp:revision>9</cp:revision>
  <dcterms:created xsi:type="dcterms:W3CDTF">2019-12-12T06:40:21Z</dcterms:created>
  <dcterms:modified xsi:type="dcterms:W3CDTF">2019-12-18T01:34:39Z</dcterms:modified>
</cp:coreProperties>
</file>